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1"/>
  </p:notesMasterIdLst>
  <p:sldIdLst>
    <p:sldId id="257" r:id="rId2"/>
    <p:sldId id="281" r:id="rId3"/>
    <p:sldId id="274" r:id="rId4"/>
    <p:sldId id="283" r:id="rId5"/>
    <p:sldId id="282" r:id="rId6"/>
    <p:sldId id="258" r:id="rId7"/>
    <p:sldId id="259" r:id="rId8"/>
    <p:sldId id="285" r:id="rId9"/>
    <p:sldId id="284" r:id="rId10"/>
    <p:sldId id="275" r:id="rId11"/>
    <p:sldId id="261" r:id="rId12"/>
    <p:sldId id="287" r:id="rId13"/>
    <p:sldId id="279" r:id="rId14"/>
    <p:sldId id="262" r:id="rId15"/>
    <p:sldId id="263" r:id="rId16"/>
    <p:sldId id="264" r:id="rId17"/>
    <p:sldId id="265" r:id="rId18"/>
    <p:sldId id="266" r:id="rId19"/>
    <p:sldId id="267" r:id="rId20"/>
    <p:sldId id="288" r:id="rId21"/>
    <p:sldId id="289" r:id="rId22"/>
    <p:sldId id="268" r:id="rId23"/>
    <p:sldId id="269" r:id="rId24"/>
    <p:sldId id="290" r:id="rId25"/>
    <p:sldId id="276" r:id="rId26"/>
    <p:sldId id="270" r:id="rId27"/>
    <p:sldId id="291" r:id="rId28"/>
    <p:sldId id="286" r:id="rId29"/>
    <p:sldId id="271" r:id="rId30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069" autoAdjust="0"/>
    <p:restoredTop sz="94674"/>
  </p:normalViewPr>
  <p:slideViewPr>
    <p:cSldViewPr snapToGrid="0">
      <p:cViewPr varScale="1">
        <p:scale>
          <a:sx n="124" d="100"/>
          <a:sy n="124" d="100"/>
        </p:scale>
        <p:origin x="175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ableStyles" Target="tableStyles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760004-4F6D-4C08-AEF0-137084071959}" type="datetimeFigureOut">
              <a:rPr lang="en-US" smtClean="0"/>
              <a:t>5/15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751616-8857-4265-A774-EE0913C1A73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0402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A760D8-98F7-4F4E-8D44-87C1E9560D8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4597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A760D8-98F7-4F4E-8D44-87C1E9560D80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5495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249AE-053B-4869-8C6E-D6D7F3FE5E74}" type="datetimeFigureOut">
              <a:rPr lang="en-US" smtClean="0"/>
              <a:t>5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2A2F5-0A40-4B0D-BFE0-2D851F40BC7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5762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249AE-053B-4869-8C6E-D6D7F3FE5E74}" type="datetimeFigureOut">
              <a:rPr lang="en-US" smtClean="0"/>
              <a:t>5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2A2F5-0A40-4B0D-BFE0-2D851F40BC7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938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249AE-053B-4869-8C6E-D6D7F3FE5E74}" type="datetimeFigureOut">
              <a:rPr lang="en-US" smtClean="0"/>
              <a:t>5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2A2F5-0A40-4B0D-BFE0-2D851F40BC7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466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249AE-053B-4869-8C6E-D6D7F3FE5E74}" type="datetimeFigureOut">
              <a:rPr lang="en-US" smtClean="0"/>
              <a:t>5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2A2F5-0A40-4B0D-BFE0-2D851F40BC7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743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249AE-053B-4869-8C6E-D6D7F3FE5E74}" type="datetimeFigureOut">
              <a:rPr lang="en-US" smtClean="0"/>
              <a:t>5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2A2F5-0A40-4B0D-BFE0-2D851F40BC7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074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249AE-053B-4869-8C6E-D6D7F3FE5E74}" type="datetimeFigureOut">
              <a:rPr lang="en-US" smtClean="0"/>
              <a:t>5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2A2F5-0A40-4B0D-BFE0-2D851F40BC7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8641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249AE-053B-4869-8C6E-D6D7F3FE5E74}" type="datetimeFigureOut">
              <a:rPr lang="en-US" smtClean="0"/>
              <a:t>5/15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2A2F5-0A40-4B0D-BFE0-2D851F40BC7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480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249AE-053B-4869-8C6E-D6D7F3FE5E74}" type="datetimeFigureOut">
              <a:rPr lang="en-US" smtClean="0"/>
              <a:t>5/15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2A2F5-0A40-4B0D-BFE0-2D851F40BC7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8102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249AE-053B-4869-8C6E-D6D7F3FE5E74}" type="datetimeFigureOut">
              <a:rPr lang="en-US" smtClean="0"/>
              <a:t>5/15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2A2F5-0A40-4B0D-BFE0-2D851F40BC7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560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249AE-053B-4869-8C6E-D6D7F3FE5E74}" type="datetimeFigureOut">
              <a:rPr lang="en-US" smtClean="0"/>
              <a:t>5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2A2F5-0A40-4B0D-BFE0-2D851F40BC7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724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249AE-053B-4869-8C6E-D6D7F3FE5E74}" type="datetimeFigureOut">
              <a:rPr lang="en-US" smtClean="0"/>
              <a:t>5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2A2F5-0A40-4B0D-BFE0-2D851F40BC7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0900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0249AE-053B-4869-8C6E-D6D7F3FE5E74}" type="datetimeFigureOut">
              <a:rPr lang="en-US" smtClean="0"/>
              <a:t>5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72A2F5-0A40-4B0D-BFE0-2D851F40BC7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517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jpeg"/><Relationship Id="rId2" Type="http://schemas.openxmlformats.org/officeDocument/2006/relationships/image" Target="../media/image35.jpe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g"/><Relationship Id="rId2" Type="http://schemas.openxmlformats.org/officeDocument/2006/relationships/image" Target="../media/image37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jpg"/><Relationship Id="rId5" Type="http://schemas.openxmlformats.org/officeDocument/2006/relationships/image" Target="../media/image40.jpg"/><Relationship Id="rId4" Type="http://schemas.openxmlformats.org/officeDocument/2006/relationships/image" Target="../media/image39.jp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5.jpg"/><Relationship Id="rId4" Type="http://schemas.openxmlformats.org/officeDocument/2006/relationships/image" Target="../media/image44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jpg"/><Relationship Id="rId2" Type="http://schemas.openxmlformats.org/officeDocument/2006/relationships/image" Target="../media/image46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jpg"/><Relationship Id="rId5" Type="http://schemas.openxmlformats.org/officeDocument/2006/relationships/image" Target="../media/image49.jpg"/><Relationship Id="rId4" Type="http://schemas.openxmlformats.org/officeDocument/2006/relationships/image" Target="../media/image48.jp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5.png"/><Relationship Id="rId5" Type="http://schemas.openxmlformats.org/officeDocument/2006/relationships/image" Target="../media/image54.png"/><Relationship Id="rId4" Type="http://schemas.openxmlformats.org/officeDocument/2006/relationships/image" Target="../media/image53.png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jp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jp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jp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jpg"/><Relationship Id="rId2" Type="http://schemas.openxmlformats.org/officeDocument/2006/relationships/image" Target="../media/image6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4.jpg"/><Relationship Id="rId4" Type="http://schemas.openxmlformats.org/officeDocument/2006/relationships/image" Target="../media/image63.jp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jpg"/><Relationship Id="rId2" Type="http://schemas.openxmlformats.org/officeDocument/2006/relationships/image" Target="../media/image6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9.jpg"/><Relationship Id="rId5" Type="http://schemas.openxmlformats.org/officeDocument/2006/relationships/image" Target="../media/image68.jpg"/><Relationship Id="rId4" Type="http://schemas.openxmlformats.org/officeDocument/2006/relationships/image" Target="../media/image67.jp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jpg"/><Relationship Id="rId2" Type="http://schemas.openxmlformats.org/officeDocument/2006/relationships/image" Target="../media/image70.jp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jpg"/><Relationship Id="rId2" Type="http://schemas.openxmlformats.org/officeDocument/2006/relationships/image" Target="../media/image72.jp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5.jpg"/><Relationship Id="rId2" Type="http://schemas.openxmlformats.org/officeDocument/2006/relationships/image" Target="../media/image74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6.jp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8.jpeg"/><Relationship Id="rId2" Type="http://schemas.openxmlformats.org/officeDocument/2006/relationships/image" Target="../media/image77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0.jpeg"/><Relationship Id="rId4" Type="http://schemas.openxmlformats.org/officeDocument/2006/relationships/image" Target="../media/image79.jpeg"/></Relationships>
</file>

<file path=ppt/slides/_rels/slide26.xml.rels><?xml version="1.0" encoding="UTF-8" standalone="yes"?>
<Relationships xmlns="http://schemas.openxmlformats.org/package/2006/relationships"><Relationship Id="rId8" Type="http://schemas.openxmlformats.org/officeDocument/2006/relationships/image" Target="../media/image86.jpg"/><Relationship Id="rId3" Type="http://schemas.openxmlformats.org/officeDocument/2006/relationships/image" Target="../media/image81.jpg"/><Relationship Id="rId7" Type="http://schemas.openxmlformats.org/officeDocument/2006/relationships/image" Target="../media/image85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4.jpg"/><Relationship Id="rId5" Type="http://schemas.openxmlformats.org/officeDocument/2006/relationships/image" Target="../media/image83.png"/><Relationship Id="rId4" Type="http://schemas.openxmlformats.org/officeDocument/2006/relationships/image" Target="../media/image82.jpe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8.jpg"/><Relationship Id="rId2" Type="http://schemas.openxmlformats.org/officeDocument/2006/relationships/image" Target="../media/image87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9.jpg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1.jpg"/><Relationship Id="rId2" Type="http://schemas.openxmlformats.org/officeDocument/2006/relationships/image" Target="../media/image90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2.jpg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e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7" Type="http://schemas.openxmlformats.org/officeDocument/2006/relationships/image" Target="../media/image18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jpg"/><Relationship Id="rId5" Type="http://schemas.openxmlformats.org/officeDocument/2006/relationships/image" Target="../media/image16.jpg"/><Relationship Id="rId4" Type="http://schemas.openxmlformats.org/officeDocument/2006/relationships/image" Target="../media/image15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g"/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g"/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7.jpg"/><Relationship Id="rId4" Type="http://schemas.openxmlformats.org/officeDocument/2006/relationships/image" Target="../media/image26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g"/><Relationship Id="rId2" Type="http://schemas.openxmlformats.org/officeDocument/2006/relationships/image" Target="../media/image28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0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g"/><Relationship Id="rId2" Type="http://schemas.openxmlformats.org/officeDocument/2006/relationships/image" Target="../media/image3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4.jpg"/><Relationship Id="rId4" Type="http://schemas.openxmlformats.org/officeDocument/2006/relationships/image" Target="../media/image3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TextBox 181"/>
          <p:cNvSpPr txBox="1"/>
          <p:nvPr/>
        </p:nvSpPr>
        <p:spPr>
          <a:xfrm>
            <a:off x="8875458" y="6360490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2076" y="-12970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867987" y="70490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6157759" y="441501"/>
            <a:ext cx="2727274" cy="2550809"/>
            <a:chOff x="788415" y="385033"/>
            <a:chExt cx="2864655" cy="2662967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8415" y="682752"/>
              <a:ext cx="2864655" cy="2365248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1493998" y="385033"/>
              <a:ext cx="986165" cy="3052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>
                  <a:latin typeface="Arial" panose="020B0604020202020204" pitchFamily="34" charset="0"/>
                  <a:cs typeface="Arial" panose="020B0604020202020204" pitchFamily="34" charset="0"/>
                </a:rPr>
                <a:t>C4-2</a:t>
              </a:r>
            </a:p>
          </p:txBody>
        </p:sp>
      </p:grpSp>
      <p:pic>
        <p:nvPicPr>
          <p:cNvPr id="9" name="Picture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256" y="349486"/>
            <a:ext cx="5263059" cy="2917893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251" y="3655542"/>
            <a:ext cx="4819650" cy="2583332"/>
          </a:xfrm>
          <a:prstGeom prst="rect">
            <a:avLst/>
          </a:prstGeom>
        </p:spPr>
      </p:pic>
      <p:sp>
        <p:nvSpPr>
          <p:cNvPr id="73" name="TextBox 72"/>
          <p:cNvSpPr txBox="1"/>
          <p:nvPr/>
        </p:nvSpPr>
        <p:spPr>
          <a:xfrm>
            <a:off x="179070" y="3360745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5867987" y="3360744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79" name="Picture 7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8006" y="3644072"/>
            <a:ext cx="2307344" cy="26102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739948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D:\PhD(DAAD-Germany-Jena)\PhD thesis\1st project, my phd project (C28)\results\for writing paper\5th draft 22.07.24\JPEG\Fig3A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2444" y="798520"/>
            <a:ext cx="7522421" cy="1690680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 descr="D:\PhD(DAAD-Germany-Jena)\PhD thesis\1st project, my phd project (C28)\results\for writing paper\5th draft 22.07.24\JPEG\Fig3B.jp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2444" y="2831601"/>
            <a:ext cx="5571083" cy="2175564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TextBox 7"/>
          <p:cNvSpPr txBox="1"/>
          <p:nvPr/>
        </p:nvSpPr>
        <p:spPr>
          <a:xfrm>
            <a:off x="345264" y="456120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45264" y="456119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45264" y="2511235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8810665" y="6258532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65054" y="5211395"/>
            <a:ext cx="9256466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5. C28 induces dual cell cycle arrest at G1/S and S/G2 transition in CRPC cells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cycle distribution analysis of treated C4-2 cells after 72 h using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pidiu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odide (PI) staining and flow cytometry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 charts depict percentage of cells in different phases as mean ± SEM from six technical replicates (n = 6) of three independent experiments.</a:t>
            </a:r>
          </a:p>
        </p:txBody>
      </p:sp>
    </p:spTree>
    <p:extLst>
      <p:ext uri="{BB962C8B-B14F-4D97-AF65-F5344CB8AC3E}">
        <p14:creationId xmlns:p14="http://schemas.microsoft.com/office/powerpoint/2010/main" val="294220307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37"/>
          <p:cNvSpPr txBox="1"/>
          <p:nvPr/>
        </p:nvSpPr>
        <p:spPr>
          <a:xfrm>
            <a:off x="187844" y="127272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6744" y="3646928"/>
            <a:ext cx="2703394" cy="2961474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3369564" y="3449754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485024" y="384612"/>
            <a:ext cx="2834640" cy="2928413"/>
            <a:chOff x="312088" y="311817"/>
            <a:chExt cx="2834640" cy="2928413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088" y="710390"/>
              <a:ext cx="2834640" cy="2529840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1044478" y="311817"/>
              <a:ext cx="986165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>
                  <a:latin typeface="Arial" panose="020B0604020202020204" pitchFamily="34" charset="0"/>
                  <a:cs typeface="Arial" panose="020B0604020202020204" pitchFamily="34" charset="0"/>
                </a:rPr>
                <a:t>C4-2</a:t>
              </a:r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9048178" y="6390970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6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6744" y="606401"/>
            <a:ext cx="2115312" cy="2706624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3369564" y="127271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B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6206098" y="127271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4703" y="423521"/>
            <a:ext cx="2139696" cy="2889504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187844" y="3450981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D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434" y="3838361"/>
            <a:ext cx="2980944" cy="25786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857394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0704" y="181293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318178" y="181293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6381041" y="181293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644334" y="594837"/>
            <a:ext cx="2637916" cy="2643577"/>
            <a:chOff x="472884" y="3804762"/>
            <a:chExt cx="2637916" cy="2643577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90" t="3722" r="1560" b="552"/>
            <a:stretch/>
          </p:blipFill>
          <p:spPr>
            <a:xfrm>
              <a:off x="522820" y="3950959"/>
              <a:ext cx="2587980" cy="249738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 rot="16200000">
              <a:off x="199904" y="4077742"/>
              <a:ext cx="8229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BL2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053909" y="6171340"/>
              <a:ext cx="8229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R</a:t>
              </a: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3623583" y="487288"/>
            <a:ext cx="2752689" cy="2751126"/>
            <a:chOff x="3452133" y="3697213"/>
            <a:chExt cx="2752689" cy="2751126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60901" y="3882819"/>
              <a:ext cx="2743921" cy="2529507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 rot="16200000">
              <a:off x="3179153" y="3970193"/>
              <a:ext cx="8229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KBP5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866738" y="6171340"/>
              <a:ext cx="8229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R</a:t>
              </a: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6613152" y="487287"/>
            <a:ext cx="2757321" cy="2751126"/>
            <a:chOff x="6441702" y="3697212"/>
            <a:chExt cx="2757321" cy="2751126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98267" y="3882819"/>
              <a:ext cx="2700756" cy="2532141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 rot="16200000">
              <a:off x="6168722" y="3970192"/>
              <a:ext cx="8229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KX3.1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993423" y="6171339"/>
              <a:ext cx="8229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R</a:t>
              </a:r>
            </a:p>
          </p:txBody>
        </p:sp>
      </p:grpSp>
      <p:pic>
        <p:nvPicPr>
          <p:cNvPr id="17" name="Picture 1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046" y="3711603"/>
            <a:ext cx="8552688" cy="2877312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219456" y="3369202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9048178" y="6390970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6</a:t>
            </a:r>
          </a:p>
        </p:txBody>
      </p:sp>
    </p:spTree>
    <p:extLst>
      <p:ext uri="{BB962C8B-B14F-4D97-AF65-F5344CB8AC3E}">
        <p14:creationId xmlns:p14="http://schemas.microsoft.com/office/powerpoint/2010/main" val="52078601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08463" y="773819"/>
            <a:ext cx="8539715" cy="2385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6. C28 enhances p130 protein levels in C4-2 cell line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istical analysis of three independent replicates of Western blot analysis in C4-2 treated cells for 72 h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 the expression level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L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PC3-AR cells following treatment with C28, SAL or DMSO. Bar graphs are shown as mean ± SEM  from six technical replicates (n = 6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 the expression level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L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22Rv1 cells following treatment with C28, SAL or DMSO from six technical replicates (n = 6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 the expression level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L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Ca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za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heroids following treatment with C28 or DMSO from six technical replicates (n = 6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: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L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vels following the treatment of PC3 cells with C28, Dar, SAL or DMSO. Bar graphs are shown as mean ± SEM  from six technical replicates (n = 6) of two independent experiments.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B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pha-Tubulin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used as housekeeping genes for normalization. A two-tailed unpaired Student t-test was performed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rrelation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L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expression in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ing GEPIA data set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analysis betwee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KBP5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expression 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ing GEPIA dataset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analysis betwee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X3.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expression 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ing GEPIA dataset. Values represent spearmen correlation coefficient. p &lt; 0.05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IP-seq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LNCaP cells treated with SAL (R1881) or DMSO as solvent control. Visualization of the occupancy of the AR to 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L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locus using IGV software. 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9048178" y="6390970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6</a:t>
            </a:r>
          </a:p>
        </p:txBody>
      </p:sp>
    </p:spTree>
    <p:extLst>
      <p:ext uri="{BB962C8B-B14F-4D97-AF65-F5344CB8AC3E}">
        <p14:creationId xmlns:p14="http://schemas.microsoft.com/office/powerpoint/2010/main" val="8777135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/>
          <p:cNvSpPr txBox="1"/>
          <p:nvPr/>
        </p:nvSpPr>
        <p:spPr>
          <a:xfrm>
            <a:off x="17800" y="90360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9005050" y="6289370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7</a:t>
            </a:r>
          </a:p>
        </p:txBody>
      </p:sp>
      <p:sp>
        <p:nvSpPr>
          <p:cNvPr id="2" name="TextBox 1"/>
          <p:cNvSpPr txBox="1"/>
          <p:nvPr/>
        </p:nvSpPr>
        <p:spPr>
          <a:xfrm rot="16200000">
            <a:off x="409313" y="4031919"/>
            <a:ext cx="17311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rvival probability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-412097" y="1159839"/>
            <a:ext cx="17311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rvival probability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396480" y="5269435"/>
            <a:ext cx="1158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ime (Years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784684" y="2189757"/>
            <a:ext cx="1158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ime (Years)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1443992" y="3326843"/>
            <a:ext cx="7110728" cy="1844597"/>
            <a:chOff x="1017272" y="3326843"/>
            <a:chExt cx="7468360" cy="2054352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7272" y="3326843"/>
              <a:ext cx="3529584" cy="2054352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56048" y="3326843"/>
              <a:ext cx="3529584" cy="2054352"/>
            </a:xfrm>
            <a:prstGeom prst="rect">
              <a:avLst/>
            </a:prstGeom>
          </p:spPr>
        </p:pic>
      </p:grpSp>
      <p:grpSp>
        <p:nvGrpSpPr>
          <p:cNvPr id="15" name="Group 14"/>
          <p:cNvGrpSpPr/>
          <p:nvPr/>
        </p:nvGrpSpPr>
        <p:grpSpPr>
          <a:xfrm>
            <a:off x="588264" y="492229"/>
            <a:ext cx="9236456" cy="1773936"/>
            <a:chOff x="588264" y="492229"/>
            <a:chExt cx="9236456" cy="1773936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8264" y="492229"/>
              <a:ext cx="3121152" cy="1773936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600"/>
            <a:stretch/>
          </p:blipFill>
          <p:spPr>
            <a:xfrm>
              <a:off x="3709416" y="492229"/>
              <a:ext cx="2999232" cy="1761744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037"/>
            <a:stretch/>
          </p:blipFill>
          <p:spPr>
            <a:xfrm>
              <a:off x="6826852" y="492229"/>
              <a:ext cx="2997868" cy="173126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36077528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409" y="411672"/>
            <a:ext cx="2722244" cy="217407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9595" y="442152"/>
            <a:ext cx="2819240" cy="216237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0777" y="442152"/>
            <a:ext cx="2755563" cy="216575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409" y="2804477"/>
            <a:ext cx="2722244" cy="2144518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0567" y="2804477"/>
            <a:ext cx="2748268" cy="2177227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863600" y="5334000"/>
            <a:ext cx="8117840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7. High expression of DREAM complex targets is related to diminished survival in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a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plan Meier survival plot  derived from human protein atlas, comparing high and low level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D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RKB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NA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L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M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with overall survival of prostate cancer patients. Numbers in the plot represent the number of patient samples per group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igher expression of DREAM complex targets in prostate adenocarcinoma samples. Normal (204), Tumor (498)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11584" y="90360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9005050" y="6289370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7</a:t>
            </a:r>
          </a:p>
        </p:txBody>
      </p:sp>
    </p:spTree>
    <p:extLst>
      <p:ext uri="{BB962C8B-B14F-4D97-AF65-F5344CB8AC3E}">
        <p14:creationId xmlns:p14="http://schemas.microsoft.com/office/powerpoint/2010/main" val="349077039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422" y="534416"/>
            <a:ext cx="9150096" cy="519988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882352" y="6068407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8</a:t>
            </a:r>
          </a:p>
        </p:txBody>
      </p:sp>
    </p:spTree>
    <p:extLst>
      <p:ext uri="{BB962C8B-B14F-4D97-AF65-F5344CB8AC3E}">
        <p14:creationId xmlns:p14="http://schemas.microsoft.com/office/powerpoint/2010/main" val="173254312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307832" y="3697060"/>
            <a:ext cx="9110345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8. p130 specifically recruits to the regulatory regions of the DREAM complex targe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</a:p>
          <a:p>
            <a:pPr algn="just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30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IP-seq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and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b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IP-seq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C4-2 cells were used. Visualization of the occupancy of the p130 to the regulatory region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D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RKB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NA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L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M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ing IGV.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832" y="387096"/>
            <a:ext cx="4480560" cy="236524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8934604" y="5937777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8</a:t>
            </a:r>
          </a:p>
        </p:txBody>
      </p:sp>
    </p:spTree>
    <p:extLst>
      <p:ext uri="{BB962C8B-B14F-4D97-AF65-F5344CB8AC3E}">
        <p14:creationId xmlns:p14="http://schemas.microsoft.com/office/powerpoint/2010/main" val="102712543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371091" y="1205473"/>
            <a:ext cx="3244366" cy="14927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9. Network interaction of RBL2 and DREAM complex targets with some cellular senescence marker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just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action between RBL2 and DREAM complex targets with cell cycle regulators visualized using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scap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oftware. The graph illustrates the established connections between RBL2 and DREAM complex targets.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61" t="5809" r="20308" b="2710"/>
          <a:stretch/>
        </p:blipFill>
        <p:spPr>
          <a:xfrm>
            <a:off x="365760" y="590429"/>
            <a:ext cx="5669280" cy="539496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8916098" y="6330010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9</a:t>
            </a:r>
          </a:p>
        </p:txBody>
      </p:sp>
    </p:spTree>
    <p:extLst>
      <p:ext uri="{BB962C8B-B14F-4D97-AF65-F5344CB8AC3E}">
        <p14:creationId xmlns:p14="http://schemas.microsoft.com/office/powerpoint/2010/main" val="420953002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7559" y="3058410"/>
            <a:ext cx="9577898" cy="2160983"/>
            <a:chOff x="231233" y="3808046"/>
            <a:chExt cx="9577898" cy="2160983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582" r="5417" b="63840"/>
            <a:stretch/>
          </p:blipFill>
          <p:spPr>
            <a:xfrm>
              <a:off x="1587151" y="3808046"/>
              <a:ext cx="8221980" cy="1693049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4982061" y="5630574"/>
              <a:ext cx="1091139" cy="3384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38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AD2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312523" y="4654570"/>
              <a:ext cx="1254760" cy="7016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13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ti-AR + </a:t>
              </a:r>
              <a:r>
                <a:rPr lang="en-US" sz="813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sz="813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813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813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ti-AR + DHT (SAL)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231233" y="4059346"/>
              <a:ext cx="1366530" cy="3384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38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enomic Locus</a:t>
              </a: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233214" y="5440840"/>
            <a:ext cx="9110345" cy="815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10. SAL leads to recruitment of AR to the ATAD2 gene loc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D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RNA of C4-2 spheroids treated with SAL or DMSO. Bar graphs are shown as mean ± SEM  from six technical replicates (n = 6) of two independent experiment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IP-seq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C4-2 cells treated with SAL (DHT). Visualization of the occupancy of the AR to the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D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loci using IGV. 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49049" y="90633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49049" y="2477114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916098" y="6330010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10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720824" y="419569"/>
            <a:ext cx="2084832" cy="2221725"/>
            <a:chOff x="869414" y="147304"/>
            <a:chExt cx="2084832" cy="2221725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9414" y="442693"/>
              <a:ext cx="2084832" cy="1926336"/>
            </a:xfrm>
            <a:prstGeom prst="rect">
              <a:avLst/>
            </a:prstGeom>
          </p:spPr>
        </p:pic>
        <p:sp>
          <p:nvSpPr>
            <p:cNvPr id="2" name="Textfeld 1">
              <a:extLst>
                <a:ext uri="{FF2B5EF4-FFF2-40B4-BE49-F238E27FC236}">
                  <a16:creationId xmlns:a16="http://schemas.microsoft.com/office/drawing/2014/main" id="{4A3903F2-9FB2-2E4D-F623-6162CDFA6068}"/>
                </a:ext>
              </a:extLst>
            </p:cNvPr>
            <p:cNvSpPr txBox="1"/>
            <p:nvPr/>
          </p:nvSpPr>
          <p:spPr>
            <a:xfrm>
              <a:off x="1404089" y="147304"/>
              <a:ext cx="12041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4-2 </a:t>
              </a:r>
              <a:r>
                <a:rPr lang="de-DE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pheroids</a:t>
              </a:r>
              <a:endParaRPr lang="de-DE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846601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TextBox 63"/>
          <p:cNvSpPr txBox="1"/>
          <p:nvPr/>
        </p:nvSpPr>
        <p:spPr>
          <a:xfrm>
            <a:off x="590550" y="3668992"/>
            <a:ext cx="8705850" cy="23237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1. Both AR-agonist and -antagonists downregulate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TERT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.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the expression of  positively-regulated AR target gene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LK3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PRSS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C4-2 cells following C28 (30 µM), Dar (10 µM), SAL or DMSO treatments using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. Bar graphs are shown as mean ± SEM  from nine technical replicates (n = 9) of three independent experiments.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: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the expression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KBP5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X3.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PC3-AR cells following treatment with C28 (30 µM), SAL or DMSO from six technical replicates (n = 6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the mRNA levels of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TER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negatively-regulated AR target gene in C4-2 cells,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lowing C28 (30 µM), Dar (10 µM), SAL or DMSO treatments using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. . Bar graphs are shown as mean ± SEM  from nine technical replicates (n = 9) of three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: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TER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PC3-AR cells following treatment with C28 (30 µM), SAL or DMSO from six technical replicates (n = 6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the expression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KBP5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X3.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22Rv1 cells following treatment with C28 (30 µM), SAL or DMSO using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. . Bar graphs are shown as mean ± SEM  from six technical replicates (n = 6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: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TE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PC3 cells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lowing C28 (30 µM), Dar (10 µM), SAL or DMSO treatments . Bar graphs are shown as mean ± SEM  from six technical replicates (n = 6) of two independent experiments.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B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pha-Tubulin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used as housekeeping genes for normalization. A two-tailed unpaired Student t-test was performed for statistical analysis.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8875458" y="6360490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</a:p>
        </p:txBody>
      </p:sp>
      <p:grpSp>
        <p:nvGrpSpPr>
          <p:cNvPr id="69" name="Group 68"/>
          <p:cNvGrpSpPr/>
          <p:nvPr/>
        </p:nvGrpSpPr>
        <p:grpSpPr>
          <a:xfrm>
            <a:off x="6390066" y="708279"/>
            <a:ext cx="2485392" cy="2473072"/>
            <a:chOff x="4174068" y="559742"/>
            <a:chExt cx="2777062" cy="2717548"/>
          </a:xfrm>
        </p:grpSpPr>
        <p:pic>
          <p:nvPicPr>
            <p:cNvPr id="70" name="Picture 69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74068" y="919152"/>
              <a:ext cx="2777062" cy="2358138"/>
            </a:xfrm>
            <a:prstGeom prst="rect">
              <a:avLst/>
            </a:prstGeom>
          </p:spPr>
        </p:pic>
        <p:sp>
          <p:nvSpPr>
            <p:cNvPr id="71" name="TextBox 70"/>
            <p:cNvSpPr txBox="1"/>
            <p:nvPr/>
          </p:nvSpPr>
          <p:spPr>
            <a:xfrm>
              <a:off x="4811594" y="559742"/>
              <a:ext cx="57912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>
                  <a:latin typeface="Arial" panose="020B0604020202020204" pitchFamily="34" charset="0"/>
                  <a:cs typeface="Arial" panose="020B0604020202020204" pitchFamily="34" charset="0"/>
                </a:rPr>
                <a:t>PC3</a:t>
              </a:r>
            </a:p>
          </p:txBody>
        </p:sp>
      </p:grpSp>
      <p:sp>
        <p:nvSpPr>
          <p:cNvPr id="72" name="TextBox 71"/>
          <p:cNvSpPr txBox="1"/>
          <p:nvPr/>
        </p:nvSpPr>
        <p:spPr>
          <a:xfrm>
            <a:off x="6123319" y="406517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75" name="Picture 7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142" y="708279"/>
            <a:ext cx="5081356" cy="2659954"/>
          </a:xfrm>
          <a:prstGeom prst="rect">
            <a:avLst/>
          </a:prstGeom>
        </p:spPr>
      </p:pic>
      <p:sp>
        <p:nvSpPr>
          <p:cNvPr id="76" name="TextBox 75"/>
          <p:cNvSpPr txBox="1"/>
          <p:nvPr/>
        </p:nvSpPr>
        <p:spPr>
          <a:xfrm>
            <a:off x="441960" y="406517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82231150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916098" y="6330010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11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874" y="442919"/>
            <a:ext cx="2370701" cy="278638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9169" y="607511"/>
            <a:ext cx="2276605" cy="261484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0724" y="547698"/>
            <a:ext cx="2332470" cy="262730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47233" y="271719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A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9276"/>
          <a:stretch/>
        </p:blipFill>
        <p:spPr>
          <a:xfrm>
            <a:off x="469258" y="3517403"/>
            <a:ext cx="2687302" cy="2803197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47233" y="3175002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27" r="33907"/>
          <a:stretch/>
        </p:blipFill>
        <p:spPr>
          <a:xfrm>
            <a:off x="3156560" y="3511307"/>
            <a:ext cx="2830883" cy="280319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983" r="86"/>
          <a:stretch/>
        </p:blipFill>
        <p:spPr>
          <a:xfrm>
            <a:off x="5862183" y="3505211"/>
            <a:ext cx="2617941" cy="28031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066136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955708" y="250327"/>
            <a:ext cx="3697577" cy="39241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11. DREAM complex is activated in an AR-signaling dependent manne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D2, AURKB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CNA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s following the treatment of PC3-AR cells with C28, SAL or DMSO. Bar graphs are shown as mean ± SEM  from six technical replicates (n = 6) of two independent experiment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D2, AURKB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CNA2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s following the treatment of PC3 cells with C28, Dar, SAL or DMSO from six technical replicates (n = 6) of two independent experiments.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: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D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URKB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s following the treatment of 22Rv1 cells with C28, SAL or DMSO. Bar graphs are shown as mean ± SEM  from six technical replicates (n = 6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D2, AURKB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CNA2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levels in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Ca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za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heroids following treatment with C28 or DMSO from six technical replicates (n = 6) of two independent experiments.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B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pha-Tubulin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used as housekeeping genes for normalization. A two-tailed unpaired Student t-test was used for comparing treatment with the control.</a:t>
            </a:r>
          </a:p>
          <a:p>
            <a:pPr algn="just"/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612" y="249130"/>
            <a:ext cx="2473640" cy="304124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7352" y="315772"/>
            <a:ext cx="2449256" cy="297460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46022" y="144571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46022" y="3416333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D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202" y="3697837"/>
            <a:ext cx="3302080" cy="297324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8252" y="4038249"/>
            <a:ext cx="2211279" cy="266927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8990" y="3952525"/>
            <a:ext cx="2130326" cy="2632828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8916098" y="6330010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11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0285" y="4038249"/>
            <a:ext cx="2130326" cy="26328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9429161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65773" y="130259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930" y="384122"/>
            <a:ext cx="9351264" cy="28651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828" y="3562614"/>
            <a:ext cx="2225040" cy="243230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062948" y="6428591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12</a:t>
            </a:r>
          </a:p>
        </p:txBody>
      </p:sp>
    </p:spTree>
    <p:extLst>
      <p:ext uri="{BB962C8B-B14F-4D97-AF65-F5344CB8AC3E}">
        <p14:creationId xmlns:p14="http://schemas.microsoft.com/office/powerpoint/2010/main" val="254452478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TextBox 120"/>
          <p:cNvSpPr txBox="1"/>
          <p:nvPr/>
        </p:nvSpPr>
        <p:spPr>
          <a:xfrm>
            <a:off x="207730" y="319136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910" y="661537"/>
            <a:ext cx="8253984" cy="2353056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910" y="3474693"/>
            <a:ext cx="5254752" cy="186537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9154389" y="6428591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12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85725" y="5400059"/>
            <a:ext cx="9618047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12. SAL downregulates DREAM complex targets in xenograft tumor samples. </a:t>
            </a:r>
          </a:p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expression analysis of DREAM complex targets 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Ca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treated with vehicle or SAL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-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expression analysis of DREAM complex targets in PDX xenograft tumors treated with vehicle or SAL. Although the p-value is not significant (ns),  a downward trend in the expression of the DREAM complex target is observed in SAL-treated PDX xenograft. A two-tailed unpaired Student t-test was used for comparing treatment with the control</a:t>
            </a:r>
          </a:p>
        </p:txBody>
      </p:sp>
    </p:spTree>
    <p:extLst>
      <p:ext uri="{BB962C8B-B14F-4D97-AF65-F5344CB8AC3E}">
        <p14:creationId xmlns:p14="http://schemas.microsoft.com/office/powerpoint/2010/main" val="2998462105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9141326" y="6428591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13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347" y="331034"/>
            <a:ext cx="6965823" cy="454197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4339" y="22048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173527" y="-11367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B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47180" y="464657"/>
            <a:ext cx="2346960" cy="204825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929" y="5136501"/>
            <a:ext cx="1761627" cy="1538097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34339" y="4893847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395367" y="5181999"/>
            <a:ext cx="709563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13. C28 reduces AURKB protein levels in 2D adherent cells and 3D tumor spheroids. </a:t>
            </a:r>
          </a:p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RKB immunofluorescence staining in C4-2 spheroids. Samples without primary antibody serve as a negative control. Scale bars indicate 10 µm. The red stripe we consider as an artefact based on overlaying of cell layers via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parartion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fication of AURKB positive signals per area. Bar graphs are shown as mean ± SEM  from ten technical replicates (n = 10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analysis of AURKB in treated C4-2 cells. The expression was normalized to β-Actin as loading control. Numbers indicate normalized band intensities relative to DMSO control. </a:t>
            </a:r>
          </a:p>
        </p:txBody>
      </p:sp>
    </p:spTree>
    <p:extLst>
      <p:ext uri="{BB962C8B-B14F-4D97-AF65-F5344CB8AC3E}">
        <p14:creationId xmlns:p14="http://schemas.microsoft.com/office/powerpoint/2010/main" val="280826082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073" y="499867"/>
            <a:ext cx="3310128" cy="1740550"/>
          </a:xfrm>
          <a:prstGeom prst="rect">
            <a:avLst/>
          </a:prstGeom>
        </p:spPr>
      </p:pic>
      <p:grpSp>
        <p:nvGrpSpPr>
          <p:cNvPr id="10" name="Group 9"/>
          <p:cNvGrpSpPr/>
          <p:nvPr/>
        </p:nvGrpSpPr>
        <p:grpSpPr>
          <a:xfrm>
            <a:off x="4418786" y="340355"/>
            <a:ext cx="5304333" cy="5480542"/>
            <a:chOff x="4418786" y="340355"/>
            <a:chExt cx="5304333" cy="5480542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18786" y="340355"/>
              <a:ext cx="5202863" cy="3683000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999"/>
            <a:stretch/>
          </p:blipFill>
          <p:spPr>
            <a:xfrm>
              <a:off x="5078182" y="4094475"/>
              <a:ext cx="4644937" cy="1726422"/>
            </a:xfrm>
            <a:prstGeom prst="rect">
              <a:avLst/>
            </a:prstGeom>
          </p:spPr>
        </p:pic>
      </p:grpSp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073" y="2690871"/>
            <a:ext cx="3289996" cy="168960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126681" y="309866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08431" y="274315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08431" y="2519670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141326" y="6428591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14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69818" y="4668944"/>
            <a:ext cx="4637314" cy="1846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14. DYRK1A inhibition counteracts cellular senescence induced by AR-antagonists or -agonist</a:t>
            </a:r>
          </a:p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4-2 cells were treated for 72 h with AZ191 (800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 DYRK1A inhibitor (DYRK1A-i), either alone or in combination with C28 (30 µM), Dar (10 µM), 1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1881 (SAL) or DMSO as a solvent control. Representative images of cells stained for SA 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al activity are shown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rystal violet staining of C4-2 cells treated with AR-ligands, either alone or in combination with AZ191, was performed over a 9-day period to assess cell growth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images of SA 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al staining in C4-2 cells transfected with siDYRK1A following treatment with AR-ligands or DMSO for 48 h</a:t>
            </a:r>
          </a:p>
        </p:txBody>
      </p:sp>
    </p:spTree>
    <p:extLst>
      <p:ext uri="{BB962C8B-B14F-4D97-AF65-F5344CB8AC3E}">
        <p14:creationId xmlns:p14="http://schemas.microsoft.com/office/powerpoint/2010/main" val="1230046097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Box 56"/>
          <p:cNvSpPr txBox="1"/>
          <p:nvPr/>
        </p:nvSpPr>
        <p:spPr>
          <a:xfrm>
            <a:off x="181250" y="117737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6480871" y="117736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6764792" y="277361"/>
            <a:ext cx="2607086" cy="2831239"/>
            <a:chOff x="3980791" y="277361"/>
            <a:chExt cx="2607086" cy="283123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80791" y="520270"/>
              <a:ext cx="2607086" cy="2588330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4634134" y="277361"/>
              <a:ext cx="5791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PC3</a:t>
              </a:r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8916098" y="6330010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15</a:t>
            </a: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24517" y="3782925"/>
            <a:ext cx="3987800" cy="2047972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5405715" y="3351509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245018" y="489790"/>
            <a:ext cx="3557462" cy="2183666"/>
            <a:chOff x="361201" y="653534"/>
            <a:chExt cx="3557462" cy="2183666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0981" y="703181"/>
              <a:ext cx="3178489" cy="1846109"/>
            </a:xfrm>
            <a:prstGeom prst="rect">
              <a:avLst/>
            </a:prstGeom>
          </p:spPr>
        </p:pic>
        <p:sp>
          <p:nvSpPr>
            <p:cNvPr id="50" name="Rectangle 49"/>
            <p:cNvSpPr/>
            <p:nvPr/>
          </p:nvSpPr>
          <p:spPr>
            <a:xfrm>
              <a:off x="2375922" y="1790999"/>
              <a:ext cx="81724" cy="81725"/>
            </a:xfrm>
            <a:prstGeom prst="rect">
              <a:avLst/>
            </a:prstGeom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63"/>
            </a:p>
          </p:txBody>
        </p:sp>
        <p:sp>
          <p:nvSpPr>
            <p:cNvPr id="51" name="Rectangle 50"/>
            <p:cNvSpPr/>
            <p:nvPr/>
          </p:nvSpPr>
          <p:spPr>
            <a:xfrm>
              <a:off x="2375922" y="1987681"/>
              <a:ext cx="81724" cy="81725"/>
            </a:xfrm>
            <a:prstGeom prst="rect">
              <a:avLst/>
            </a:prstGeom>
            <a:solidFill>
              <a:srgbClr val="E391E3"/>
            </a:solidFill>
            <a:ln>
              <a:solidFill>
                <a:srgbClr val="E391E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63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2421324" y="1742444"/>
              <a:ext cx="1296418" cy="2048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31" b="1" dirty="0">
                  <a:latin typeface="Arial" panose="020B0604020202020204" pitchFamily="34" charset="0"/>
                  <a:cs typeface="Arial" panose="020B0604020202020204" pitchFamily="34" charset="0"/>
                </a:rPr>
                <a:t>Low expression (n = 300)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2421325" y="1940676"/>
              <a:ext cx="1497338" cy="2048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31" b="1" dirty="0">
                  <a:latin typeface="Arial" panose="020B0604020202020204" pitchFamily="34" charset="0"/>
                  <a:cs typeface="Arial" panose="020B0604020202020204" pitchFamily="34" charset="0"/>
                </a:rPr>
                <a:t>High expression (n = 180)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907165" y="2094206"/>
              <a:ext cx="840135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>
                  <a:latin typeface="Arial" panose="020B0604020202020204" pitchFamily="34" charset="0"/>
                  <a:cs typeface="Arial" panose="020B0604020202020204" pitchFamily="34" charset="0"/>
                </a:rPr>
                <a:t>CCNG2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601861" y="2560201"/>
              <a:ext cx="11582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ime (Years)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-365876" y="1380611"/>
              <a:ext cx="17311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rvival probability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574552" y="2114619"/>
              <a:ext cx="788408" cy="2048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31" b="1" dirty="0">
                  <a:latin typeface="Arial" panose="020B0604020202020204" pitchFamily="34" charset="0"/>
                  <a:cs typeface="Arial" panose="020B0604020202020204" pitchFamily="34" charset="0"/>
                </a:rPr>
                <a:t>P value 0.13</a:t>
              </a:r>
            </a:p>
          </p:txBody>
        </p:sp>
      </p:grpSp>
      <p:pic>
        <p:nvPicPr>
          <p:cNvPr id="6" name="Picture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4488" y="407399"/>
            <a:ext cx="2249971" cy="2701201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4128226" y="117736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B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427902" y="3351509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E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34928" y="3351509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D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018" y="3695777"/>
            <a:ext cx="2081595" cy="285166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4801" y="3829638"/>
            <a:ext cx="2889504" cy="2609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2011074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433" y="718147"/>
            <a:ext cx="3754120" cy="215639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46253" y="286730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683830" y="286730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5081688" y="652756"/>
            <a:ext cx="2956560" cy="3248655"/>
            <a:chOff x="386370" y="3473245"/>
            <a:chExt cx="2956560" cy="3248655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6370" y="3704380"/>
              <a:ext cx="2956560" cy="301752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909740" y="3473245"/>
              <a:ext cx="986165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>
                  <a:latin typeface="Arial" panose="020B0604020202020204" pitchFamily="34" charset="0"/>
                  <a:cs typeface="Arial" panose="020B0604020202020204" pitchFamily="34" charset="0"/>
                </a:rPr>
                <a:t>C4-2</a:t>
              </a:r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346253" y="3228206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656495" y="3457039"/>
            <a:ext cx="3194304" cy="3254127"/>
            <a:chOff x="4057764" y="3473245"/>
            <a:chExt cx="3194304" cy="3254127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617"/>
            <a:stretch/>
          </p:blipFill>
          <p:spPr>
            <a:xfrm>
              <a:off x="4057764" y="3593313"/>
              <a:ext cx="3194304" cy="3134059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4634134" y="3473245"/>
              <a:ext cx="986165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>
                  <a:latin typeface="Arial" panose="020B0604020202020204" pitchFamily="34" charset="0"/>
                  <a:cs typeface="Arial" panose="020B0604020202020204" pitchFamily="34" charset="0"/>
                </a:rPr>
                <a:t>C4-2</a:t>
              </a: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8916098" y="6330010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15</a:t>
            </a:r>
          </a:p>
        </p:txBody>
      </p:sp>
    </p:spTree>
    <p:extLst>
      <p:ext uri="{BB962C8B-B14F-4D97-AF65-F5344CB8AC3E}">
        <p14:creationId xmlns:p14="http://schemas.microsoft.com/office/powerpoint/2010/main" val="386087258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7932" y="331206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J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112" y="709091"/>
            <a:ext cx="2775016" cy="380934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1546" y="816308"/>
            <a:ext cx="2743481" cy="3702123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7592" y="942445"/>
            <a:ext cx="2756095" cy="357598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8916098" y="6330010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15</a:t>
            </a:r>
          </a:p>
        </p:txBody>
      </p:sp>
    </p:spTree>
    <p:extLst>
      <p:ext uri="{BB962C8B-B14F-4D97-AF65-F5344CB8AC3E}">
        <p14:creationId xmlns:p14="http://schemas.microsoft.com/office/powerpoint/2010/main" val="54075688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97181" y="460138"/>
            <a:ext cx="8039047" cy="3346947"/>
            <a:chOff x="77255" y="442431"/>
            <a:chExt cx="8039047" cy="3346947"/>
          </a:xfrm>
        </p:grpSpPr>
        <p:sp>
          <p:nvSpPr>
            <p:cNvPr id="3" name="Rectangle 2"/>
            <p:cNvSpPr/>
            <p:nvPr/>
          </p:nvSpPr>
          <p:spPr>
            <a:xfrm>
              <a:off x="243840" y="727530"/>
              <a:ext cx="1385722" cy="28989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38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enomic Locus</a:t>
              </a:r>
            </a:p>
          </p:txBody>
        </p:sp>
        <p:sp>
          <p:nvSpPr>
            <p:cNvPr id="4" name="Rectangle 3"/>
            <p:cNvSpPr/>
            <p:nvPr/>
          </p:nvSpPr>
          <p:spPr>
            <a:xfrm>
              <a:off x="77255" y="1278779"/>
              <a:ext cx="1576433" cy="1970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ti-p130</a:t>
              </a:r>
            </a:p>
            <a:p>
              <a:pPr algn="ctr"/>
              <a:endParaRPr lang="en-US" sz="813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ti-p130</a:t>
              </a:r>
              <a:r>
                <a:rPr lang="en-US" sz="813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narrow peaks</a:t>
              </a:r>
            </a:p>
            <a:p>
              <a:pPr algn="ctr"/>
              <a:endParaRPr lang="en-US" sz="813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ti-</a:t>
              </a:r>
              <a:r>
                <a:rPr lang="en-US" sz="10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b</a:t>
              </a:r>
              <a:endParaRPr lang="en-US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813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813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ti-</a:t>
              </a:r>
              <a:r>
                <a:rPr lang="en-US" sz="813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b</a:t>
              </a:r>
              <a:r>
                <a:rPr lang="en-US" sz="813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narrow peaks</a:t>
              </a:r>
            </a:p>
            <a:p>
              <a:pPr algn="ctr"/>
              <a:endParaRPr lang="en-US" sz="813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813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ti-E2F1</a:t>
              </a:r>
              <a:r>
                <a:rPr lang="en-US" sz="813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endParaRPr lang="en-US" sz="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ti-E2F1</a:t>
              </a:r>
              <a:r>
                <a:rPr lang="en-US" sz="813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narrow peaks</a:t>
              </a:r>
            </a:p>
            <a:p>
              <a:pPr algn="ctr"/>
              <a:endParaRPr lang="en-US" sz="813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813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feld 3">
              <a:extLst>
                <a:ext uri="{FF2B5EF4-FFF2-40B4-BE49-F238E27FC236}">
                  <a16:creationId xmlns:a16="http://schemas.microsoft.com/office/drawing/2014/main" id="{676F1714-17A3-CF09-C44E-4F78D465EB86}"/>
                </a:ext>
              </a:extLst>
            </p:cNvPr>
            <p:cNvSpPr txBox="1"/>
            <p:nvPr/>
          </p:nvSpPr>
          <p:spPr>
            <a:xfrm>
              <a:off x="658540" y="445593"/>
              <a:ext cx="909223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3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hIP-seq</a:t>
              </a:r>
              <a:endParaRPr lang="de-DE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Rectangle 5"/>
            <p:cNvSpPr/>
            <p:nvPr/>
          </p:nvSpPr>
          <p:spPr>
            <a:xfrm>
              <a:off x="198880" y="3123844"/>
              <a:ext cx="1333183" cy="3384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38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f </a:t>
              </a:r>
              <a:r>
                <a:rPr lang="en-US" sz="1138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q</a:t>
              </a:r>
              <a:r>
                <a:rPr lang="en-US" sz="1138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Gene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4614604" y="3450923"/>
              <a:ext cx="1031875" cy="3384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38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CNG2</a:t>
              </a: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463" r="39256" b="38188"/>
            <a:stretch/>
          </p:blipFill>
          <p:spPr>
            <a:xfrm>
              <a:off x="1653688" y="442431"/>
              <a:ext cx="6462614" cy="2894132"/>
            </a:xfrm>
            <a:prstGeom prst="rect">
              <a:avLst/>
            </a:prstGeom>
          </p:spPr>
        </p:pic>
      </p:grpSp>
      <p:sp>
        <p:nvSpPr>
          <p:cNvPr id="10" name="TextBox 9"/>
          <p:cNvSpPr txBox="1"/>
          <p:nvPr/>
        </p:nvSpPr>
        <p:spPr>
          <a:xfrm>
            <a:off x="1" y="117737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9137907" y="6473046"/>
            <a:ext cx="602615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15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" y="3807085"/>
            <a:ext cx="9689961" cy="29392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15. GGNG2 knockdown leads to growth promotion in CRPC cell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plan Meier survival plot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NG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prostate cancer pati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NG2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s following the treatment of PC3-AR cells with C28, SAL or DMSO. Bar graphs are shown as mean ± SEM  from six technical replicates (n = 6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: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NG2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s following the treatment of PC3 cells with C28, Dar, SAL or DMSO from six technical replicates (n = 6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NG2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s in 22Rv1 cells following treatment with C28, SAL or DMSO using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. Bar graphs are shown as mean ± SEM  from six technical replicates (n = 6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NG2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s in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Ca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za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heroids following treatment with C28 or DMSO using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. Bar graphs are shown as mean ± SEM  from six technical replicates (n = 6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images showing SA 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al staining in C4-2 cells transfected with siRNA targeting CCNG2 and treated for 48 h with C28 (30 µM), Dar (10 µM), 1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1881 (SAL) or DMSO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ystal violet staining was carried out on the same plates used for SA 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al staining, measuring the growth of siCCNG2 transfected cells treated by various AR-ligand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wth assay of transfected C4-2 cells with siCCNG2 following AR-ligand treatments, using crystal violet. Bar graphs are shown as mean ± SEM  from four technical replicates (n = 4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: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NG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vels following the treatment of C4-2 cells with AZ191, DYRK1A-I, in combination with AR-antagonists and -agonist from six technical replicates (n = 6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mRNA levels of DREAM targets following knockdown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NG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C4-2 cells using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. Bar graphs are shown as mean ± SEM  from six technical replicates (n = 6) </a:t>
            </a:r>
            <a:r>
              <a:rPr lang="en-US" sz="1100">
                <a:latin typeface="Times New Roman" panose="02020603050405020304" pitchFamily="18" charset="0"/>
                <a:cs typeface="Times New Roman" panose="02020603050405020304" pitchFamily="18" charset="0"/>
              </a:rPr>
              <a:t>of two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ependent experiments</a:t>
            </a:r>
            <a:r>
              <a:rPr lang="en-US" sz="110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i="1">
                <a:latin typeface="Times New Roman" panose="02020603050405020304" pitchFamily="18" charset="0"/>
                <a:cs typeface="Times New Roman" panose="02020603050405020304" pitchFamily="18" charset="0"/>
              </a:rPr>
              <a:t>TBP</a:t>
            </a:r>
            <a:r>
              <a:rPr lang="en-US" sz="11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pha-Tubulin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used as housekeeping genes for normalization. A two-tailed unpaired Student t-test was performed for statistical analysi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IP-seq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indicates p130 and E2F1 occupancy at the regulatory regions of CCNG2 in C4-2 cells. IGV software was used for visualization. 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191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3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1614" y="4978449"/>
            <a:ext cx="2672974" cy="1760992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389" y="531469"/>
            <a:ext cx="3592555" cy="353568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0959" y="533501"/>
            <a:ext cx="4237736" cy="122214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875458" y="6334364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97747" y="189068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951045" y="189068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1779" y="2224064"/>
            <a:ext cx="2606255" cy="2648950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3963571" y="2073841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66242" y="2491398"/>
            <a:ext cx="2829483" cy="1745990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6880670" y="2073840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29" name="Picture 28" descr="C:\Users\golia\Desktop\Picture1.jpg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9382" y="4221626"/>
            <a:ext cx="2484337" cy="2517815"/>
          </a:xfrm>
          <a:prstGeom prst="rect">
            <a:avLst/>
          </a:prstGeom>
          <a:noFill/>
          <a:ln>
            <a:noFill/>
          </a:ln>
        </p:spPr>
      </p:pic>
      <p:sp>
        <p:nvSpPr>
          <p:cNvPr id="30" name="TextBox 29"/>
          <p:cNvSpPr txBox="1"/>
          <p:nvPr/>
        </p:nvSpPr>
        <p:spPr>
          <a:xfrm>
            <a:off x="99649" y="4099158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E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210596" y="4701813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309838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6546" y="3566639"/>
            <a:ext cx="2434125" cy="246623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840" y="3641996"/>
            <a:ext cx="2434125" cy="239087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51660" y="3224239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J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387956" y="3224238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K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03070" y="164221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G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029444" y="164221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H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400250" y="439395"/>
            <a:ext cx="2648898" cy="2301816"/>
            <a:chOff x="776998" y="927666"/>
            <a:chExt cx="2718816" cy="2510182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6998" y="1268927"/>
              <a:ext cx="2718816" cy="2168921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1561217" y="927666"/>
              <a:ext cx="579120" cy="3356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cs typeface="Arial" panose="020B0604020202020204" pitchFamily="34" charset="0"/>
                </a:rPr>
                <a:t>PC3</a:t>
              </a:r>
            </a:p>
          </p:txBody>
        </p:sp>
      </p:grpSp>
      <p:pic>
        <p:nvPicPr>
          <p:cNvPr id="12" name="Picture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5214" y="439395"/>
            <a:ext cx="2996375" cy="2583272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7585" y="307585"/>
            <a:ext cx="2741378" cy="2715082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6627406" y="164221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I</a:t>
            </a:r>
          </a:p>
        </p:txBody>
      </p:sp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698"/>
          <a:stretch/>
        </p:blipFill>
        <p:spPr>
          <a:xfrm>
            <a:off x="6943353" y="3207831"/>
            <a:ext cx="2372098" cy="2825044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6627406" y="3224238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L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8875458" y="6334364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</a:p>
        </p:txBody>
      </p:sp>
    </p:spTree>
    <p:extLst>
      <p:ext uri="{BB962C8B-B14F-4D97-AF65-F5344CB8AC3E}">
        <p14:creationId xmlns:p14="http://schemas.microsoft.com/office/powerpoint/2010/main" val="35084836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57734" y="3200842"/>
            <a:ext cx="9269260" cy="3339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2. C28 inhibits CRPC cell growth via induction of cellular senescence in an AR-dependent manner.</a:t>
            </a:r>
          </a:p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rystal violet staining of the growth curve over 9 days for adherent C4-2 cells treated with C28 (30 µM), Dar (10 µM), SAL (1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1881), or DMSO. Bar graphs are shown as mean ± SEM  from four technical replicates (n = 4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images of SA 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al activity staining in C4-2 cells after 72 h of treatment with AR-ligands from twelve technical replicates (n = 12) of three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: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N2B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in C4-2 cells treated for 72 h. . Bar graphs are shown as mean ± SEM  from nine technical replicates (n = 9) of three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tection of p15INK4b by Western blotting of 2D adherent culture after 72 h treatment with C28 (30 µM), AA (100 µM), Dar (10 µM), SAL (R1881 1nM), or DMSO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N2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expression levels in C4-2 cells treated for 72 h from nine technical replicates (n = 9) of three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: 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ction of p16 INK4a by Western blotting of 2D adherent culture after 72 h treatment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ing crystal violet staining shows no growth inhibition of PC3 cells by AR-ligand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SA β-Gal positive PC3 cells. Data are presented as mean ± SEM from eight technical replicates (n = 8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: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N2B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vels following the treatment of PC3 cells with C28 (30 µM), Dar (10 µM), SAL or DMSO from six technical replicates (n = 6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ing crystal violet staining shows growth inhibition of PC3-AR cells by AR-ligands. Bar graphs are shown as mean ± SEM  from four technical replicates (n = 4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SA β-Gal positive PC3-AR cells. Data are presented as mean ± SEM from eight technical replicates (n = 8) of two independent experiments.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: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N2B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vels following the treatment of PC3-AR cells with C28 (30 µM), SAL or DMSO from six technical replicates (n = 6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ing crystal violet staining shows no growth inhibition of 22Rv1 cells by AR-ligand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SA β-Gal positive 22Rv1 cells. Data are presented as mean ± SEM from eight technical replicates (n = 8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: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N2B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vels following the treatment of 22Rv1 cells with C28 (30 µM), SAL or DMSO from six technical replicates (n = 6) of two independent experiments.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B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pha-Tubulin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used as housekeeping genes for normalization. A two-tailed unpaired Student t-test was performed for statistical analysis.       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57734" y="66472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M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629377" y="66472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N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3065" y="318135"/>
            <a:ext cx="2865120" cy="277368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5175885" y="66472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O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5310" y="412933"/>
            <a:ext cx="2182368" cy="2548128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004" y="382453"/>
            <a:ext cx="2206752" cy="2578608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8875458" y="6334364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</a:p>
        </p:txBody>
      </p:sp>
    </p:spTree>
    <p:extLst>
      <p:ext uri="{BB962C8B-B14F-4D97-AF65-F5344CB8AC3E}">
        <p14:creationId xmlns:p14="http://schemas.microsoft.com/office/powerpoint/2010/main" val="20345914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/>
          <p:cNvSpPr txBox="1"/>
          <p:nvPr/>
        </p:nvSpPr>
        <p:spPr>
          <a:xfrm>
            <a:off x="88813" y="196740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104102" y="3291213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81" name="Picture 180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282" y="539141"/>
            <a:ext cx="7398656" cy="2054482"/>
          </a:xfrm>
          <a:prstGeom prst="rect">
            <a:avLst/>
          </a:prstGeom>
        </p:spPr>
      </p:pic>
      <p:pic>
        <p:nvPicPr>
          <p:cNvPr id="182" name="Picture 18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515" y="3633614"/>
            <a:ext cx="9064752" cy="204216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8980482" y="6389161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</a:p>
        </p:txBody>
      </p:sp>
    </p:spTree>
    <p:extLst>
      <p:ext uri="{BB962C8B-B14F-4D97-AF65-F5344CB8AC3E}">
        <p14:creationId xmlns:p14="http://schemas.microsoft.com/office/powerpoint/2010/main" val="1865581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545" y="3742134"/>
            <a:ext cx="2785872" cy="2767584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111584" y="90360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111584" y="3452685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3270447" y="90360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E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385" y="376613"/>
            <a:ext cx="2785070" cy="240722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0447" y="4083510"/>
            <a:ext cx="2828544" cy="2084832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9150299" y="6415286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270447" y="3583052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7627" y="376612"/>
            <a:ext cx="4370832" cy="31424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006198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300231" y="-16564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3586" y="236841"/>
            <a:ext cx="2889504" cy="214579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5085" y="2393138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330" y="2564339"/>
            <a:ext cx="6022848" cy="2170176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03670" y="4734515"/>
            <a:ext cx="949433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3. C28 inhibits AR transactivation in in vitro and in vivo studies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mRNA levels of AR target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X3.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KBP5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TE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re detected in C4-2 spheroids treated with C28 or DMSO. Bar graphs are shown as mean ± SEM  from six technical replicates (n = 6) of two independent experiment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mRNA levels of AR targets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X3.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KBP5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TE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re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aze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C4-2 xenografts treated with C28 (N = 6), DHT (SAL, N = 7) or vehicle control (N =5).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B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pha-Tubulin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used as housekeeping genes for normalization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centage of inhibitory effects of C28 and DHT (SAL) at Day 20, % ΔT/ΔC tumor volume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vato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i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ight from C28 (N = 6) or DHT (SAL, N = 7) treated mice compared to vehicle control (N = 5)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 &amp; E (Hematoxylin and Eosin) staining of mouse prostate.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images were taken at the same magnification and processed similarly to allow direct comparisons (20x)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-I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 levels of AR target genes in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enografte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 (C28 = 6, DHT = 7, vehicle control = 5) organs were analyzed by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.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pl13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used as a housekeeping gene for normalization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u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in kidney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sn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x9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prostate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tp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Liver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d3b6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ox5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estes. A two-tailed unpaired Student t-test was performed for statistical analysis.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137236" y="6415286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7529" y="-16564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25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330" y="279513"/>
            <a:ext cx="5894832" cy="2103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00949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137236" y="6415286"/>
            <a:ext cx="699359" cy="217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13" b="1" dirty="0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436" y="1201495"/>
            <a:ext cx="2279904" cy="4956048"/>
          </a:xfrm>
          <a:prstGeom prst="rect">
            <a:avLst/>
          </a:prstGeom>
        </p:spPr>
      </p:pic>
      <p:sp>
        <p:nvSpPr>
          <p:cNvPr id="4" name="Rectangle 283"/>
          <p:cNvSpPr>
            <a:spLocks noChangeArrowheads="1"/>
          </p:cNvSpPr>
          <p:nvPr/>
        </p:nvSpPr>
        <p:spPr bwMode="auto">
          <a:xfrm>
            <a:off x="889921" y="723723"/>
            <a:ext cx="2943044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de-DE" altLang="de-DE" sz="1500" b="1" dirty="0">
                <a:solidFill>
                  <a:srgbClr val="000000"/>
                </a:solidFill>
                <a:latin typeface="+mn-lt"/>
              </a:rPr>
              <a:t>LNCaP Abl EnzaR spheroids</a:t>
            </a:r>
            <a:endParaRPr lang="de-DE" altLang="de-DE" sz="1500" dirty="0">
              <a:latin typeface="+mn-lt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0762" y="839139"/>
            <a:ext cx="2905350" cy="296868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76926" y="303224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383582" y="303224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B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05629" y="645624"/>
            <a:ext cx="2529840" cy="1426464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6730119" y="303223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0762" y="3923236"/>
            <a:ext cx="2181419" cy="2768445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3383582" y="3715531"/>
            <a:ext cx="297180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25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D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024826" y="4057932"/>
            <a:ext cx="3790088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4. C28 does not inhibit the growth of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CaP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l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za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 cell line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ration and treatment of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Ca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za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mor spheroids with C28 (30 µM) or DMSO as a solvent control for 13 days. Scale bars indicate 100 µm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significant growth inhibition. Bar graphs are shown as mean ± SEM  from twenty technical replicates (n = 20) of two independent experiments.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 β-Gal activity staining as a cellular senescence marker in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Ca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za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heroids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: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N2B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5INK4b in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Ca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za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heroids from six technical replicates (n = 6) of two independent experiments.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B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pha-Tubulin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used as housekeeping genes for normalization. A two-tailed unpaired Student t-test was performed.</a:t>
            </a:r>
          </a:p>
        </p:txBody>
      </p:sp>
    </p:spTree>
    <p:extLst>
      <p:ext uri="{BB962C8B-B14F-4D97-AF65-F5344CB8AC3E}">
        <p14:creationId xmlns:p14="http://schemas.microsoft.com/office/powerpoint/2010/main" val="35575571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151</Words>
  <Application>Microsoft Macintosh PowerPoint</Application>
  <PresentationFormat>A4-Papier (210 x 297 mm)</PresentationFormat>
  <Paragraphs>180</Paragraphs>
  <Slides>29</Slides>
  <Notes>2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9</vt:i4>
      </vt:variant>
    </vt:vector>
  </HeadingPairs>
  <TitlesOfParts>
    <vt:vector size="34" baseType="lpstr">
      <vt:lpstr>Arial</vt:lpstr>
      <vt:lpstr>Calibri</vt:lpstr>
      <vt:lpstr>Calibri Light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lia</dc:creator>
  <cp:lastModifiedBy>Microsoft Office User</cp:lastModifiedBy>
  <cp:revision>108</cp:revision>
  <dcterms:created xsi:type="dcterms:W3CDTF">2024-07-22T06:23:46Z</dcterms:created>
  <dcterms:modified xsi:type="dcterms:W3CDTF">2025-05-15T12:57:44Z</dcterms:modified>
</cp:coreProperties>
</file>